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8" r:id="rId3"/>
    <p:sldId id="265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2" autoAdjust="0"/>
  </p:normalViewPr>
  <p:slideViewPr>
    <p:cSldViewPr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327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596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935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634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01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585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884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243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726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733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818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17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164068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. 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781050"/>
            <a:ext cx="3429000" cy="3429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362200" y="12954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9.5 x10</a:t>
            </a:r>
            <a:r>
              <a:rPr lang="en-US" sz="1200" baseline="30000" dirty="0" smtClean="0"/>
              <a:t>-3</a:t>
            </a:r>
            <a:endParaRPr lang="en-US" sz="1200" baseline="30000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4699" y="838200"/>
            <a:ext cx="3408107" cy="337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5410200" y="12954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2.0 x10</a:t>
            </a:r>
            <a:r>
              <a:rPr lang="en-US" sz="1200" baseline="30000" dirty="0" smtClean="0"/>
              <a:t>-8</a:t>
            </a:r>
            <a:endParaRPr lang="en-US" sz="1200" baseline="30000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4114800"/>
            <a:ext cx="3466158" cy="320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201013" y="45720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0.0027</a:t>
            </a:r>
            <a:endParaRPr lang="en-US" sz="1200" baseline="30000" dirty="0"/>
          </a:p>
        </p:txBody>
      </p:sp>
      <p:sp>
        <p:nvSpPr>
          <p:cNvPr id="9" name="TextBox 8"/>
          <p:cNvSpPr txBox="1"/>
          <p:nvPr/>
        </p:nvSpPr>
        <p:spPr>
          <a:xfrm>
            <a:off x="781050" y="3718381"/>
            <a:ext cx="236220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38600" y="3724275"/>
            <a:ext cx="236220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76300" y="6928306"/>
            <a:ext cx="236220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0268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164068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. 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675" y="504825"/>
            <a:ext cx="4876800" cy="42537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70" y="4858347"/>
            <a:ext cx="4626030" cy="42856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184056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935" y="533400"/>
            <a:ext cx="2362065" cy="2209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7878" y="519945"/>
            <a:ext cx="2364421" cy="23085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519945"/>
            <a:ext cx="2384653" cy="23085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457344" y="810332"/>
            <a:ext cx="9524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=2.0x10</a:t>
            </a:r>
            <a:r>
              <a:rPr 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6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67027" y="810336"/>
            <a:ext cx="9524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=1.5x10</a:t>
            </a:r>
            <a:r>
              <a:rPr 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53000" y="810336"/>
            <a:ext cx="9524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=0.08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6200" y="452795"/>
            <a:ext cx="304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A</a:t>
            </a:r>
            <a:endParaRPr lang="en-US" sz="1600" dirty="0"/>
          </a:p>
        </p:txBody>
      </p:sp>
      <p:sp>
        <p:nvSpPr>
          <p:cNvPr id="10" name="TextBox 9"/>
          <p:cNvSpPr txBox="1"/>
          <p:nvPr/>
        </p:nvSpPr>
        <p:spPr>
          <a:xfrm>
            <a:off x="2281941" y="443270"/>
            <a:ext cx="304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B</a:t>
            </a:r>
            <a:endParaRPr lang="en-US" sz="1600" dirty="0"/>
          </a:p>
        </p:txBody>
      </p:sp>
      <p:sp>
        <p:nvSpPr>
          <p:cNvPr id="11" name="TextBox 10"/>
          <p:cNvSpPr txBox="1"/>
          <p:nvPr/>
        </p:nvSpPr>
        <p:spPr>
          <a:xfrm>
            <a:off x="4497688" y="441067"/>
            <a:ext cx="304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C</a:t>
            </a:r>
            <a:endParaRPr lang="en-US" sz="1600" dirty="0"/>
          </a:p>
        </p:txBody>
      </p:sp>
      <p:sp>
        <p:nvSpPr>
          <p:cNvPr id="12" name="Rectangle 11"/>
          <p:cNvSpPr/>
          <p:nvPr/>
        </p:nvSpPr>
        <p:spPr>
          <a:xfrm>
            <a:off x="304800" y="164068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. 6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6622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0</TotalTime>
  <Words>47</Words>
  <Application>Microsoft Office PowerPoint</Application>
  <PresentationFormat>Letter Paper (8.5x11 in)</PresentationFormat>
  <Paragraphs>1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bien</dc:creator>
  <cp:lastModifiedBy>gbien</cp:lastModifiedBy>
  <cp:revision>71</cp:revision>
  <dcterms:created xsi:type="dcterms:W3CDTF">2013-12-03T16:45:08Z</dcterms:created>
  <dcterms:modified xsi:type="dcterms:W3CDTF">2014-06-25T19:30:47Z</dcterms:modified>
</cp:coreProperties>
</file>